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5580063" cy="5580063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B106EB-C3E8-4BBE-9D80-16275D3036C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279360" y="223920"/>
            <a:ext cx="5021280" cy="930240"/>
          </a:xfrm>
          <a:prstGeom prst="rect">
            <a:avLst/>
          </a:prstGeom>
          <a:noFill/>
          <a:ln w="0">
            <a:noFill/>
          </a:ln>
        </p:spPr>
        <p:txBody>
          <a:bodyPr lIns="63720" rIns="63720" tIns="32040" bIns="32040" anchor="ctr">
            <a:noAutofit/>
          </a:bodyPr>
          <a:p>
            <a:pPr indent="0" algn="ctr">
              <a:buNone/>
              <a:tabLst>
                <a:tab algn="l" pos="0"/>
                <a:tab algn="l" pos="638280"/>
                <a:tab algn="l" pos="1276200"/>
                <a:tab algn="l" pos="1914480"/>
                <a:tab algn="l" pos="2552760"/>
                <a:tab algn="l" pos="3191040"/>
                <a:tab algn="l" pos="3828960"/>
                <a:tab algn="l" pos="4467240"/>
                <a:tab algn="l" pos="5105520"/>
                <a:tab algn="l" pos="5743440"/>
                <a:tab algn="l" pos="6381720"/>
                <a:tab algn="l" pos="7020000"/>
                <a:tab algn="l" pos="7658280"/>
                <a:tab algn="l" pos="8296200"/>
                <a:tab algn="l" pos="8934480"/>
                <a:tab algn="l" pos="9572760"/>
                <a:tab algn="l" pos="10210680"/>
                <a:tab algn="l" pos="10848960"/>
              </a:tabLst>
            </a:pPr>
            <a:endParaRPr b="0" lang="en-US" sz="3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279360" y="1301400"/>
            <a:ext cx="5021280" cy="1756800"/>
          </a:xfrm>
          <a:prstGeom prst="rect">
            <a:avLst/>
          </a:prstGeom>
          <a:noFill/>
          <a:ln w="0">
            <a:noFill/>
          </a:ln>
        </p:spPr>
        <p:txBody>
          <a:bodyPr lIns="63720" rIns="6372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38280"/>
                <a:tab algn="l" pos="1276200"/>
                <a:tab algn="l" pos="1914480"/>
                <a:tab algn="l" pos="2552760"/>
                <a:tab algn="l" pos="3191040"/>
                <a:tab algn="l" pos="3828960"/>
                <a:tab algn="l" pos="4467240"/>
                <a:tab algn="l" pos="5105520"/>
                <a:tab algn="l" pos="5743440"/>
                <a:tab algn="l" pos="6381720"/>
                <a:tab algn="l" pos="7020000"/>
                <a:tab algn="l" pos="7658280"/>
                <a:tab algn="l" pos="8296200"/>
                <a:tab algn="l" pos="8934480"/>
                <a:tab algn="l" pos="9572760"/>
                <a:tab algn="l" pos="10210680"/>
                <a:tab algn="l" pos="1084896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279360" y="3225600"/>
            <a:ext cx="5021280" cy="1756800"/>
          </a:xfrm>
          <a:prstGeom prst="rect">
            <a:avLst/>
          </a:prstGeom>
          <a:noFill/>
          <a:ln w="0">
            <a:noFill/>
          </a:ln>
        </p:spPr>
        <p:txBody>
          <a:bodyPr lIns="63720" rIns="6372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38280"/>
                <a:tab algn="l" pos="1276200"/>
                <a:tab algn="l" pos="1914480"/>
                <a:tab algn="l" pos="2552760"/>
                <a:tab algn="l" pos="3191040"/>
                <a:tab algn="l" pos="3828960"/>
                <a:tab algn="l" pos="4467240"/>
                <a:tab algn="l" pos="5105520"/>
                <a:tab algn="l" pos="5743440"/>
                <a:tab algn="l" pos="6381720"/>
                <a:tab algn="l" pos="7020000"/>
                <a:tab algn="l" pos="7658280"/>
                <a:tab algn="l" pos="8296200"/>
                <a:tab algn="l" pos="8934480"/>
                <a:tab algn="l" pos="9572760"/>
                <a:tab algn="l" pos="10210680"/>
                <a:tab algn="l" pos="1084896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EFE5FB-4158-415E-A24E-1547ADB2EE5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279360" y="223920"/>
            <a:ext cx="5021280" cy="930240"/>
          </a:xfrm>
          <a:prstGeom prst="rect">
            <a:avLst/>
          </a:prstGeom>
          <a:noFill/>
          <a:ln w="0">
            <a:noFill/>
          </a:ln>
        </p:spPr>
        <p:txBody>
          <a:bodyPr lIns="63720" rIns="63720" tIns="32040" bIns="32040" anchor="ctr">
            <a:noAutofit/>
          </a:bodyPr>
          <a:p>
            <a:pPr indent="0" algn="ctr">
              <a:buNone/>
              <a:tabLst>
                <a:tab algn="l" pos="0"/>
                <a:tab algn="l" pos="638280"/>
                <a:tab algn="l" pos="1276200"/>
                <a:tab algn="l" pos="1914480"/>
                <a:tab algn="l" pos="2552760"/>
                <a:tab algn="l" pos="3191040"/>
                <a:tab algn="l" pos="3828960"/>
                <a:tab algn="l" pos="4467240"/>
                <a:tab algn="l" pos="5105520"/>
                <a:tab algn="l" pos="5743440"/>
                <a:tab algn="l" pos="6381720"/>
                <a:tab algn="l" pos="7020000"/>
                <a:tab algn="l" pos="7658280"/>
                <a:tab algn="l" pos="8296200"/>
                <a:tab algn="l" pos="8934480"/>
                <a:tab algn="l" pos="9572760"/>
                <a:tab algn="l" pos="10210680"/>
                <a:tab algn="l" pos="10848960"/>
              </a:tabLst>
            </a:pPr>
            <a:endParaRPr b="0" lang="en-US" sz="3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279360" y="1301400"/>
            <a:ext cx="2450160" cy="1756800"/>
          </a:xfrm>
          <a:prstGeom prst="rect">
            <a:avLst/>
          </a:prstGeom>
          <a:noFill/>
          <a:ln w="0">
            <a:noFill/>
          </a:ln>
        </p:spPr>
        <p:txBody>
          <a:bodyPr lIns="63720" rIns="6372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38280"/>
                <a:tab algn="l" pos="1276200"/>
                <a:tab algn="l" pos="1914480"/>
                <a:tab algn="l" pos="2552760"/>
                <a:tab algn="l" pos="3191040"/>
                <a:tab algn="l" pos="3828960"/>
                <a:tab algn="l" pos="4467240"/>
                <a:tab algn="l" pos="5105520"/>
                <a:tab algn="l" pos="5743440"/>
                <a:tab algn="l" pos="6381720"/>
                <a:tab algn="l" pos="7020000"/>
                <a:tab algn="l" pos="7658280"/>
                <a:tab algn="l" pos="8296200"/>
                <a:tab algn="l" pos="8934480"/>
                <a:tab algn="l" pos="9572760"/>
                <a:tab algn="l" pos="10210680"/>
                <a:tab algn="l" pos="1084896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2852280" y="1301400"/>
            <a:ext cx="2450160" cy="1756800"/>
          </a:xfrm>
          <a:prstGeom prst="rect">
            <a:avLst/>
          </a:prstGeom>
          <a:noFill/>
          <a:ln w="0">
            <a:noFill/>
          </a:ln>
        </p:spPr>
        <p:txBody>
          <a:bodyPr lIns="63720" rIns="6372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38280"/>
                <a:tab algn="l" pos="1276200"/>
                <a:tab algn="l" pos="1914480"/>
                <a:tab algn="l" pos="2552760"/>
                <a:tab algn="l" pos="3191040"/>
                <a:tab algn="l" pos="3828960"/>
                <a:tab algn="l" pos="4467240"/>
                <a:tab algn="l" pos="5105520"/>
                <a:tab algn="l" pos="5743440"/>
                <a:tab algn="l" pos="6381720"/>
                <a:tab algn="l" pos="7020000"/>
                <a:tab algn="l" pos="7658280"/>
                <a:tab algn="l" pos="8296200"/>
                <a:tab algn="l" pos="8934480"/>
                <a:tab algn="l" pos="9572760"/>
                <a:tab algn="l" pos="10210680"/>
                <a:tab algn="l" pos="1084896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279360" y="3225600"/>
            <a:ext cx="2450160" cy="1756800"/>
          </a:xfrm>
          <a:prstGeom prst="rect">
            <a:avLst/>
          </a:prstGeom>
          <a:noFill/>
          <a:ln w="0">
            <a:noFill/>
          </a:ln>
        </p:spPr>
        <p:txBody>
          <a:bodyPr lIns="63720" rIns="6372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38280"/>
                <a:tab algn="l" pos="1276200"/>
                <a:tab algn="l" pos="1914480"/>
                <a:tab algn="l" pos="2552760"/>
                <a:tab algn="l" pos="3191040"/>
                <a:tab algn="l" pos="3828960"/>
                <a:tab algn="l" pos="4467240"/>
                <a:tab algn="l" pos="5105520"/>
                <a:tab algn="l" pos="5743440"/>
                <a:tab algn="l" pos="6381720"/>
                <a:tab algn="l" pos="7020000"/>
                <a:tab algn="l" pos="7658280"/>
                <a:tab algn="l" pos="8296200"/>
                <a:tab algn="l" pos="8934480"/>
                <a:tab algn="l" pos="9572760"/>
                <a:tab algn="l" pos="10210680"/>
                <a:tab algn="l" pos="1084896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2852280" y="3225600"/>
            <a:ext cx="2450160" cy="1756800"/>
          </a:xfrm>
          <a:prstGeom prst="rect">
            <a:avLst/>
          </a:prstGeom>
          <a:noFill/>
          <a:ln w="0">
            <a:noFill/>
          </a:ln>
        </p:spPr>
        <p:txBody>
          <a:bodyPr lIns="63720" rIns="6372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38280"/>
                <a:tab algn="l" pos="1276200"/>
                <a:tab algn="l" pos="1914480"/>
                <a:tab algn="l" pos="2552760"/>
                <a:tab algn="l" pos="3191040"/>
                <a:tab algn="l" pos="3828960"/>
                <a:tab algn="l" pos="4467240"/>
                <a:tab algn="l" pos="5105520"/>
                <a:tab algn="l" pos="5743440"/>
                <a:tab algn="l" pos="6381720"/>
                <a:tab algn="l" pos="7020000"/>
                <a:tab algn="l" pos="7658280"/>
                <a:tab algn="l" pos="8296200"/>
                <a:tab algn="l" pos="8934480"/>
                <a:tab algn="l" pos="9572760"/>
                <a:tab algn="l" pos="10210680"/>
                <a:tab algn="l" pos="1084896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E09F3E-57AF-4D5D-9B37-8150DCE7D34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279360" y="223920"/>
            <a:ext cx="5021280" cy="930240"/>
          </a:xfrm>
          <a:prstGeom prst="rect">
            <a:avLst/>
          </a:prstGeom>
          <a:noFill/>
          <a:ln w="0">
            <a:noFill/>
          </a:ln>
        </p:spPr>
        <p:txBody>
          <a:bodyPr lIns="63720" rIns="63720" tIns="32040" bIns="32040" anchor="ctr">
            <a:noAutofit/>
          </a:bodyPr>
          <a:p>
            <a:pPr indent="0" algn="ctr">
              <a:buNone/>
              <a:tabLst>
                <a:tab algn="l" pos="0"/>
                <a:tab algn="l" pos="638280"/>
                <a:tab algn="l" pos="1276200"/>
                <a:tab algn="l" pos="1914480"/>
                <a:tab algn="l" pos="2552760"/>
                <a:tab algn="l" pos="3191040"/>
                <a:tab algn="l" pos="3828960"/>
                <a:tab algn="l" pos="4467240"/>
                <a:tab algn="l" pos="5105520"/>
                <a:tab algn="l" pos="5743440"/>
                <a:tab algn="l" pos="6381720"/>
                <a:tab algn="l" pos="7020000"/>
                <a:tab algn="l" pos="7658280"/>
                <a:tab algn="l" pos="8296200"/>
                <a:tab algn="l" pos="8934480"/>
                <a:tab algn="l" pos="9572760"/>
                <a:tab algn="l" pos="10210680"/>
                <a:tab algn="l" pos="10848960"/>
              </a:tabLst>
            </a:pPr>
            <a:endParaRPr b="0" lang="en-US" sz="3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279360" y="1301400"/>
            <a:ext cx="1616760" cy="1756800"/>
          </a:xfrm>
          <a:prstGeom prst="rect">
            <a:avLst/>
          </a:prstGeom>
          <a:noFill/>
          <a:ln w="0">
            <a:noFill/>
          </a:ln>
        </p:spPr>
        <p:txBody>
          <a:bodyPr lIns="63720" rIns="6372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38280"/>
                <a:tab algn="l" pos="1276200"/>
                <a:tab algn="l" pos="1914480"/>
                <a:tab algn="l" pos="2552760"/>
                <a:tab algn="l" pos="3191040"/>
                <a:tab algn="l" pos="3828960"/>
                <a:tab algn="l" pos="4467240"/>
                <a:tab algn="l" pos="5105520"/>
                <a:tab algn="l" pos="5743440"/>
                <a:tab algn="l" pos="6381720"/>
                <a:tab algn="l" pos="7020000"/>
                <a:tab algn="l" pos="7658280"/>
                <a:tab algn="l" pos="8296200"/>
                <a:tab algn="l" pos="8934480"/>
                <a:tab algn="l" pos="9572760"/>
                <a:tab algn="l" pos="10210680"/>
                <a:tab algn="l" pos="1084896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1977480" y="1301400"/>
            <a:ext cx="1616760" cy="1756800"/>
          </a:xfrm>
          <a:prstGeom prst="rect">
            <a:avLst/>
          </a:prstGeom>
          <a:noFill/>
          <a:ln w="0">
            <a:noFill/>
          </a:ln>
        </p:spPr>
        <p:txBody>
          <a:bodyPr lIns="63720" rIns="6372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38280"/>
                <a:tab algn="l" pos="1276200"/>
                <a:tab algn="l" pos="1914480"/>
                <a:tab algn="l" pos="2552760"/>
                <a:tab algn="l" pos="3191040"/>
                <a:tab algn="l" pos="3828960"/>
                <a:tab algn="l" pos="4467240"/>
                <a:tab algn="l" pos="5105520"/>
                <a:tab algn="l" pos="5743440"/>
                <a:tab algn="l" pos="6381720"/>
                <a:tab algn="l" pos="7020000"/>
                <a:tab algn="l" pos="7658280"/>
                <a:tab algn="l" pos="8296200"/>
                <a:tab algn="l" pos="8934480"/>
                <a:tab algn="l" pos="9572760"/>
                <a:tab algn="l" pos="10210680"/>
                <a:tab algn="l" pos="1084896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3675240" y="1301400"/>
            <a:ext cx="1616760" cy="1756800"/>
          </a:xfrm>
          <a:prstGeom prst="rect">
            <a:avLst/>
          </a:prstGeom>
          <a:noFill/>
          <a:ln w="0">
            <a:noFill/>
          </a:ln>
        </p:spPr>
        <p:txBody>
          <a:bodyPr lIns="63720" rIns="6372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38280"/>
                <a:tab algn="l" pos="1276200"/>
                <a:tab algn="l" pos="1914480"/>
                <a:tab algn="l" pos="2552760"/>
                <a:tab algn="l" pos="3191040"/>
                <a:tab algn="l" pos="3828960"/>
                <a:tab algn="l" pos="4467240"/>
                <a:tab algn="l" pos="5105520"/>
                <a:tab algn="l" pos="5743440"/>
                <a:tab algn="l" pos="6381720"/>
                <a:tab algn="l" pos="7020000"/>
                <a:tab algn="l" pos="7658280"/>
                <a:tab algn="l" pos="8296200"/>
                <a:tab algn="l" pos="8934480"/>
                <a:tab algn="l" pos="9572760"/>
                <a:tab algn="l" pos="10210680"/>
                <a:tab algn="l" pos="1084896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279360" y="3225600"/>
            <a:ext cx="1616760" cy="1756800"/>
          </a:xfrm>
          <a:prstGeom prst="rect">
            <a:avLst/>
          </a:prstGeom>
          <a:noFill/>
          <a:ln w="0">
            <a:noFill/>
          </a:ln>
        </p:spPr>
        <p:txBody>
          <a:bodyPr lIns="63720" rIns="6372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38280"/>
                <a:tab algn="l" pos="1276200"/>
                <a:tab algn="l" pos="1914480"/>
                <a:tab algn="l" pos="2552760"/>
                <a:tab algn="l" pos="3191040"/>
                <a:tab algn="l" pos="3828960"/>
                <a:tab algn="l" pos="4467240"/>
                <a:tab algn="l" pos="5105520"/>
                <a:tab algn="l" pos="5743440"/>
                <a:tab algn="l" pos="6381720"/>
                <a:tab algn="l" pos="7020000"/>
                <a:tab algn="l" pos="7658280"/>
                <a:tab algn="l" pos="8296200"/>
                <a:tab algn="l" pos="8934480"/>
                <a:tab algn="l" pos="9572760"/>
                <a:tab algn="l" pos="10210680"/>
                <a:tab algn="l" pos="1084896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1977480" y="3225600"/>
            <a:ext cx="1616760" cy="1756800"/>
          </a:xfrm>
          <a:prstGeom prst="rect">
            <a:avLst/>
          </a:prstGeom>
          <a:noFill/>
          <a:ln w="0">
            <a:noFill/>
          </a:ln>
        </p:spPr>
        <p:txBody>
          <a:bodyPr lIns="63720" rIns="6372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38280"/>
                <a:tab algn="l" pos="1276200"/>
                <a:tab algn="l" pos="1914480"/>
                <a:tab algn="l" pos="2552760"/>
                <a:tab algn="l" pos="3191040"/>
                <a:tab algn="l" pos="3828960"/>
                <a:tab algn="l" pos="4467240"/>
                <a:tab algn="l" pos="5105520"/>
                <a:tab algn="l" pos="5743440"/>
                <a:tab algn="l" pos="6381720"/>
                <a:tab algn="l" pos="7020000"/>
                <a:tab algn="l" pos="7658280"/>
                <a:tab algn="l" pos="8296200"/>
                <a:tab algn="l" pos="8934480"/>
                <a:tab algn="l" pos="9572760"/>
                <a:tab algn="l" pos="10210680"/>
                <a:tab algn="l" pos="1084896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3675240" y="3225600"/>
            <a:ext cx="1616760" cy="1756800"/>
          </a:xfrm>
          <a:prstGeom prst="rect">
            <a:avLst/>
          </a:prstGeom>
          <a:noFill/>
          <a:ln w="0">
            <a:noFill/>
          </a:ln>
        </p:spPr>
        <p:txBody>
          <a:bodyPr lIns="63720" rIns="6372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38280"/>
                <a:tab algn="l" pos="1276200"/>
                <a:tab algn="l" pos="1914480"/>
                <a:tab algn="l" pos="2552760"/>
                <a:tab algn="l" pos="3191040"/>
                <a:tab algn="l" pos="3828960"/>
                <a:tab algn="l" pos="4467240"/>
                <a:tab algn="l" pos="5105520"/>
                <a:tab algn="l" pos="5743440"/>
                <a:tab algn="l" pos="6381720"/>
                <a:tab algn="l" pos="7020000"/>
                <a:tab algn="l" pos="7658280"/>
                <a:tab algn="l" pos="8296200"/>
                <a:tab algn="l" pos="8934480"/>
                <a:tab algn="l" pos="9572760"/>
                <a:tab algn="l" pos="10210680"/>
                <a:tab algn="l" pos="1084896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8EDB14-62B7-49F5-880A-EC3AFF2ADFE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279360" y="223920"/>
            <a:ext cx="5021280" cy="930240"/>
          </a:xfrm>
          <a:prstGeom prst="rect">
            <a:avLst/>
          </a:prstGeom>
          <a:noFill/>
          <a:ln w="0">
            <a:noFill/>
          </a:ln>
        </p:spPr>
        <p:txBody>
          <a:bodyPr lIns="63720" rIns="63720" tIns="32040" bIns="32040" anchor="ctr">
            <a:noAutofit/>
          </a:bodyPr>
          <a:p>
            <a:pPr indent="0" algn="ctr">
              <a:buNone/>
              <a:tabLst>
                <a:tab algn="l" pos="0"/>
                <a:tab algn="l" pos="638280"/>
                <a:tab algn="l" pos="1276200"/>
                <a:tab algn="l" pos="1914480"/>
                <a:tab algn="l" pos="2552760"/>
                <a:tab algn="l" pos="3191040"/>
                <a:tab algn="l" pos="3828960"/>
                <a:tab algn="l" pos="4467240"/>
                <a:tab algn="l" pos="5105520"/>
                <a:tab algn="l" pos="5743440"/>
                <a:tab algn="l" pos="6381720"/>
                <a:tab algn="l" pos="7020000"/>
                <a:tab algn="l" pos="7658280"/>
                <a:tab algn="l" pos="8296200"/>
                <a:tab algn="l" pos="8934480"/>
                <a:tab algn="l" pos="9572760"/>
                <a:tab algn="l" pos="10210680"/>
                <a:tab algn="l" pos="10848960"/>
              </a:tabLst>
            </a:pPr>
            <a:endParaRPr b="0" lang="en-US" sz="3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279360" y="1301400"/>
            <a:ext cx="5021280" cy="3683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550"/>
              </a:spcBef>
              <a:buNone/>
              <a:tabLst>
                <a:tab algn="l" pos="0"/>
                <a:tab algn="l" pos="638280"/>
                <a:tab algn="l" pos="1276200"/>
                <a:tab algn="l" pos="1914480"/>
                <a:tab algn="l" pos="2552760"/>
                <a:tab algn="l" pos="3191040"/>
                <a:tab algn="l" pos="3828960"/>
                <a:tab algn="l" pos="4467240"/>
                <a:tab algn="l" pos="5105520"/>
                <a:tab algn="l" pos="5743440"/>
                <a:tab algn="l" pos="6381720"/>
                <a:tab algn="l" pos="7020000"/>
                <a:tab algn="l" pos="7658280"/>
                <a:tab algn="l" pos="8296200"/>
                <a:tab algn="l" pos="8934480"/>
                <a:tab algn="l" pos="9572760"/>
                <a:tab algn="l" pos="10210680"/>
                <a:tab algn="l" pos="1084896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F023CC-F4D2-48A0-BAEE-02DDCB26A95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279360" y="223920"/>
            <a:ext cx="5021280" cy="930240"/>
          </a:xfrm>
          <a:prstGeom prst="rect">
            <a:avLst/>
          </a:prstGeom>
          <a:noFill/>
          <a:ln w="0">
            <a:noFill/>
          </a:ln>
        </p:spPr>
        <p:txBody>
          <a:bodyPr lIns="63720" rIns="63720" tIns="32040" bIns="32040" anchor="ctr">
            <a:noAutofit/>
          </a:bodyPr>
          <a:p>
            <a:pPr indent="0" algn="ctr">
              <a:buNone/>
              <a:tabLst>
                <a:tab algn="l" pos="0"/>
                <a:tab algn="l" pos="638280"/>
                <a:tab algn="l" pos="1276200"/>
                <a:tab algn="l" pos="1914480"/>
                <a:tab algn="l" pos="2552760"/>
                <a:tab algn="l" pos="3191040"/>
                <a:tab algn="l" pos="3828960"/>
                <a:tab algn="l" pos="4467240"/>
                <a:tab algn="l" pos="5105520"/>
                <a:tab algn="l" pos="5743440"/>
                <a:tab algn="l" pos="6381720"/>
                <a:tab algn="l" pos="7020000"/>
                <a:tab algn="l" pos="7658280"/>
                <a:tab algn="l" pos="8296200"/>
                <a:tab algn="l" pos="8934480"/>
                <a:tab algn="l" pos="9572760"/>
                <a:tab algn="l" pos="10210680"/>
                <a:tab algn="l" pos="10848960"/>
              </a:tabLst>
            </a:pPr>
            <a:endParaRPr b="0" lang="en-US" sz="3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279360" y="1301400"/>
            <a:ext cx="5021280" cy="3683160"/>
          </a:xfrm>
          <a:prstGeom prst="rect">
            <a:avLst/>
          </a:prstGeom>
          <a:noFill/>
          <a:ln w="0">
            <a:noFill/>
          </a:ln>
        </p:spPr>
        <p:txBody>
          <a:bodyPr lIns="63720" rIns="6372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38280"/>
                <a:tab algn="l" pos="1276200"/>
                <a:tab algn="l" pos="1914480"/>
                <a:tab algn="l" pos="2552760"/>
                <a:tab algn="l" pos="3191040"/>
                <a:tab algn="l" pos="3828960"/>
                <a:tab algn="l" pos="4467240"/>
                <a:tab algn="l" pos="5105520"/>
                <a:tab algn="l" pos="5743440"/>
                <a:tab algn="l" pos="6381720"/>
                <a:tab algn="l" pos="7020000"/>
                <a:tab algn="l" pos="7658280"/>
                <a:tab algn="l" pos="8296200"/>
                <a:tab algn="l" pos="8934480"/>
                <a:tab algn="l" pos="9572760"/>
                <a:tab algn="l" pos="10210680"/>
                <a:tab algn="l" pos="1084896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A2A972-5642-4D54-9FD7-349986508A2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279360" y="223920"/>
            <a:ext cx="5021280" cy="930240"/>
          </a:xfrm>
          <a:prstGeom prst="rect">
            <a:avLst/>
          </a:prstGeom>
          <a:noFill/>
          <a:ln w="0">
            <a:noFill/>
          </a:ln>
        </p:spPr>
        <p:txBody>
          <a:bodyPr lIns="63720" rIns="63720" tIns="32040" bIns="32040" anchor="ctr">
            <a:noAutofit/>
          </a:bodyPr>
          <a:p>
            <a:pPr indent="0" algn="ctr">
              <a:buNone/>
              <a:tabLst>
                <a:tab algn="l" pos="0"/>
                <a:tab algn="l" pos="638280"/>
                <a:tab algn="l" pos="1276200"/>
                <a:tab algn="l" pos="1914480"/>
                <a:tab algn="l" pos="2552760"/>
                <a:tab algn="l" pos="3191040"/>
                <a:tab algn="l" pos="3828960"/>
                <a:tab algn="l" pos="4467240"/>
                <a:tab algn="l" pos="5105520"/>
                <a:tab algn="l" pos="5743440"/>
                <a:tab algn="l" pos="6381720"/>
                <a:tab algn="l" pos="7020000"/>
                <a:tab algn="l" pos="7658280"/>
                <a:tab algn="l" pos="8296200"/>
                <a:tab algn="l" pos="8934480"/>
                <a:tab algn="l" pos="9572760"/>
                <a:tab algn="l" pos="10210680"/>
                <a:tab algn="l" pos="10848960"/>
              </a:tabLst>
            </a:pPr>
            <a:endParaRPr b="0" lang="en-US" sz="3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279360" y="1301400"/>
            <a:ext cx="2450160" cy="3683160"/>
          </a:xfrm>
          <a:prstGeom prst="rect">
            <a:avLst/>
          </a:prstGeom>
          <a:noFill/>
          <a:ln w="0">
            <a:noFill/>
          </a:ln>
        </p:spPr>
        <p:txBody>
          <a:bodyPr lIns="63720" rIns="6372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38280"/>
                <a:tab algn="l" pos="1276200"/>
                <a:tab algn="l" pos="1914480"/>
                <a:tab algn="l" pos="2552760"/>
                <a:tab algn="l" pos="3191040"/>
                <a:tab algn="l" pos="3828960"/>
                <a:tab algn="l" pos="4467240"/>
                <a:tab algn="l" pos="5105520"/>
                <a:tab algn="l" pos="5743440"/>
                <a:tab algn="l" pos="6381720"/>
                <a:tab algn="l" pos="7020000"/>
                <a:tab algn="l" pos="7658280"/>
                <a:tab algn="l" pos="8296200"/>
                <a:tab algn="l" pos="8934480"/>
                <a:tab algn="l" pos="9572760"/>
                <a:tab algn="l" pos="10210680"/>
                <a:tab algn="l" pos="1084896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2852280" y="1301400"/>
            <a:ext cx="2450160" cy="3683160"/>
          </a:xfrm>
          <a:prstGeom prst="rect">
            <a:avLst/>
          </a:prstGeom>
          <a:noFill/>
          <a:ln w="0">
            <a:noFill/>
          </a:ln>
        </p:spPr>
        <p:txBody>
          <a:bodyPr lIns="63720" rIns="6372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38280"/>
                <a:tab algn="l" pos="1276200"/>
                <a:tab algn="l" pos="1914480"/>
                <a:tab algn="l" pos="2552760"/>
                <a:tab algn="l" pos="3191040"/>
                <a:tab algn="l" pos="3828960"/>
                <a:tab algn="l" pos="4467240"/>
                <a:tab algn="l" pos="5105520"/>
                <a:tab algn="l" pos="5743440"/>
                <a:tab algn="l" pos="6381720"/>
                <a:tab algn="l" pos="7020000"/>
                <a:tab algn="l" pos="7658280"/>
                <a:tab algn="l" pos="8296200"/>
                <a:tab algn="l" pos="8934480"/>
                <a:tab algn="l" pos="9572760"/>
                <a:tab algn="l" pos="10210680"/>
                <a:tab algn="l" pos="1084896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DB2310-9432-4D8F-AF45-7AE475434A9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279360" y="223920"/>
            <a:ext cx="5021280" cy="930240"/>
          </a:xfrm>
          <a:prstGeom prst="rect">
            <a:avLst/>
          </a:prstGeom>
          <a:noFill/>
          <a:ln w="0">
            <a:noFill/>
          </a:ln>
        </p:spPr>
        <p:txBody>
          <a:bodyPr lIns="63720" rIns="63720" tIns="32040" bIns="32040" anchor="ctr">
            <a:noAutofit/>
          </a:bodyPr>
          <a:p>
            <a:pPr indent="0" algn="ctr">
              <a:buNone/>
              <a:tabLst>
                <a:tab algn="l" pos="0"/>
                <a:tab algn="l" pos="638280"/>
                <a:tab algn="l" pos="1276200"/>
                <a:tab algn="l" pos="1914480"/>
                <a:tab algn="l" pos="2552760"/>
                <a:tab algn="l" pos="3191040"/>
                <a:tab algn="l" pos="3828960"/>
                <a:tab algn="l" pos="4467240"/>
                <a:tab algn="l" pos="5105520"/>
                <a:tab algn="l" pos="5743440"/>
                <a:tab algn="l" pos="6381720"/>
                <a:tab algn="l" pos="7020000"/>
                <a:tab algn="l" pos="7658280"/>
                <a:tab algn="l" pos="8296200"/>
                <a:tab algn="l" pos="8934480"/>
                <a:tab algn="l" pos="9572760"/>
                <a:tab algn="l" pos="10210680"/>
                <a:tab algn="l" pos="10848960"/>
              </a:tabLst>
            </a:pPr>
            <a:endParaRPr b="0" lang="en-US" sz="3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1A0CF2-381B-4C9D-92BC-AEC0C6F45E3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279360" y="223920"/>
            <a:ext cx="5021280" cy="4313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550"/>
              </a:spcBef>
              <a:tabLst>
                <a:tab algn="l" pos="0"/>
                <a:tab algn="l" pos="638280"/>
                <a:tab algn="l" pos="1276200"/>
                <a:tab algn="l" pos="1914480"/>
                <a:tab algn="l" pos="2552760"/>
                <a:tab algn="l" pos="3191040"/>
                <a:tab algn="l" pos="3828960"/>
                <a:tab algn="l" pos="4467240"/>
                <a:tab algn="l" pos="5105520"/>
                <a:tab algn="l" pos="5743440"/>
                <a:tab algn="l" pos="6381720"/>
                <a:tab algn="l" pos="7020000"/>
                <a:tab algn="l" pos="7658280"/>
                <a:tab algn="l" pos="8296200"/>
                <a:tab algn="l" pos="8934480"/>
                <a:tab algn="l" pos="9572760"/>
                <a:tab algn="l" pos="10210680"/>
                <a:tab algn="l" pos="1084896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F2E403-8A9D-4E57-B6B8-55FDC504C08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279360" y="223920"/>
            <a:ext cx="5021280" cy="930240"/>
          </a:xfrm>
          <a:prstGeom prst="rect">
            <a:avLst/>
          </a:prstGeom>
          <a:noFill/>
          <a:ln w="0">
            <a:noFill/>
          </a:ln>
        </p:spPr>
        <p:txBody>
          <a:bodyPr lIns="63720" rIns="63720" tIns="32040" bIns="32040" anchor="ctr">
            <a:noAutofit/>
          </a:bodyPr>
          <a:p>
            <a:pPr indent="0" algn="ctr">
              <a:buNone/>
              <a:tabLst>
                <a:tab algn="l" pos="0"/>
                <a:tab algn="l" pos="638280"/>
                <a:tab algn="l" pos="1276200"/>
                <a:tab algn="l" pos="1914480"/>
                <a:tab algn="l" pos="2552760"/>
                <a:tab algn="l" pos="3191040"/>
                <a:tab algn="l" pos="3828960"/>
                <a:tab algn="l" pos="4467240"/>
                <a:tab algn="l" pos="5105520"/>
                <a:tab algn="l" pos="5743440"/>
                <a:tab algn="l" pos="6381720"/>
                <a:tab algn="l" pos="7020000"/>
                <a:tab algn="l" pos="7658280"/>
                <a:tab algn="l" pos="8296200"/>
                <a:tab algn="l" pos="8934480"/>
                <a:tab algn="l" pos="9572760"/>
                <a:tab algn="l" pos="10210680"/>
                <a:tab algn="l" pos="10848960"/>
              </a:tabLst>
            </a:pPr>
            <a:endParaRPr b="0" lang="en-US" sz="3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279360" y="1301400"/>
            <a:ext cx="2450160" cy="1756800"/>
          </a:xfrm>
          <a:prstGeom prst="rect">
            <a:avLst/>
          </a:prstGeom>
          <a:noFill/>
          <a:ln w="0">
            <a:noFill/>
          </a:ln>
        </p:spPr>
        <p:txBody>
          <a:bodyPr lIns="63720" rIns="6372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38280"/>
                <a:tab algn="l" pos="1276200"/>
                <a:tab algn="l" pos="1914480"/>
                <a:tab algn="l" pos="2552760"/>
                <a:tab algn="l" pos="3191040"/>
                <a:tab algn="l" pos="3828960"/>
                <a:tab algn="l" pos="4467240"/>
                <a:tab algn="l" pos="5105520"/>
                <a:tab algn="l" pos="5743440"/>
                <a:tab algn="l" pos="6381720"/>
                <a:tab algn="l" pos="7020000"/>
                <a:tab algn="l" pos="7658280"/>
                <a:tab algn="l" pos="8296200"/>
                <a:tab algn="l" pos="8934480"/>
                <a:tab algn="l" pos="9572760"/>
                <a:tab algn="l" pos="10210680"/>
                <a:tab algn="l" pos="1084896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2852280" y="1301400"/>
            <a:ext cx="2450160" cy="3683160"/>
          </a:xfrm>
          <a:prstGeom prst="rect">
            <a:avLst/>
          </a:prstGeom>
          <a:noFill/>
          <a:ln w="0">
            <a:noFill/>
          </a:ln>
        </p:spPr>
        <p:txBody>
          <a:bodyPr lIns="63720" rIns="6372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38280"/>
                <a:tab algn="l" pos="1276200"/>
                <a:tab algn="l" pos="1914480"/>
                <a:tab algn="l" pos="2552760"/>
                <a:tab algn="l" pos="3191040"/>
                <a:tab algn="l" pos="3828960"/>
                <a:tab algn="l" pos="4467240"/>
                <a:tab algn="l" pos="5105520"/>
                <a:tab algn="l" pos="5743440"/>
                <a:tab algn="l" pos="6381720"/>
                <a:tab algn="l" pos="7020000"/>
                <a:tab algn="l" pos="7658280"/>
                <a:tab algn="l" pos="8296200"/>
                <a:tab algn="l" pos="8934480"/>
                <a:tab algn="l" pos="9572760"/>
                <a:tab algn="l" pos="10210680"/>
                <a:tab algn="l" pos="1084896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279360" y="3225600"/>
            <a:ext cx="2450160" cy="1756800"/>
          </a:xfrm>
          <a:prstGeom prst="rect">
            <a:avLst/>
          </a:prstGeom>
          <a:noFill/>
          <a:ln w="0">
            <a:noFill/>
          </a:ln>
        </p:spPr>
        <p:txBody>
          <a:bodyPr lIns="63720" rIns="6372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38280"/>
                <a:tab algn="l" pos="1276200"/>
                <a:tab algn="l" pos="1914480"/>
                <a:tab algn="l" pos="2552760"/>
                <a:tab algn="l" pos="3191040"/>
                <a:tab algn="l" pos="3828960"/>
                <a:tab algn="l" pos="4467240"/>
                <a:tab algn="l" pos="5105520"/>
                <a:tab algn="l" pos="5743440"/>
                <a:tab algn="l" pos="6381720"/>
                <a:tab algn="l" pos="7020000"/>
                <a:tab algn="l" pos="7658280"/>
                <a:tab algn="l" pos="8296200"/>
                <a:tab algn="l" pos="8934480"/>
                <a:tab algn="l" pos="9572760"/>
                <a:tab algn="l" pos="10210680"/>
                <a:tab algn="l" pos="1084896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FAD9E9-1B05-4F5E-9640-D0764F4B731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279360" y="223920"/>
            <a:ext cx="5021280" cy="930240"/>
          </a:xfrm>
          <a:prstGeom prst="rect">
            <a:avLst/>
          </a:prstGeom>
          <a:noFill/>
          <a:ln w="0">
            <a:noFill/>
          </a:ln>
        </p:spPr>
        <p:txBody>
          <a:bodyPr lIns="63720" rIns="63720" tIns="32040" bIns="32040" anchor="ctr">
            <a:noAutofit/>
          </a:bodyPr>
          <a:p>
            <a:pPr indent="0" algn="ctr">
              <a:buNone/>
              <a:tabLst>
                <a:tab algn="l" pos="0"/>
                <a:tab algn="l" pos="638280"/>
                <a:tab algn="l" pos="1276200"/>
                <a:tab algn="l" pos="1914480"/>
                <a:tab algn="l" pos="2552760"/>
                <a:tab algn="l" pos="3191040"/>
                <a:tab algn="l" pos="3828960"/>
                <a:tab algn="l" pos="4467240"/>
                <a:tab algn="l" pos="5105520"/>
                <a:tab algn="l" pos="5743440"/>
                <a:tab algn="l" pos="6381720"/>
                <a:tab algn="l" pos="7020000"/>
                <a:tab algn="l" pos="7658280"/>
                <a:tab algn="l" pos="8296200"/>
                <a:tab algn="l" pos="8934480"/>
                <a:tab algn="l" pos="9572760"/>
                <a:tab algn="l" pos="10210680"/>
                <a:tab algn="l" pos="10848960"/>
              </a:tabLst>
            </a:pPr>
            <a:endParaRPr b="0" lang="en-US" sz="3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279360" y="1301400"/>
            <a:ext cx="2450160" cy="3683160"/>
          </a:xfrm>
          <a:prstGeom prst="rect">
            <a:avLst/>
          </a:prstGeom>
          <a:noFill/>
          <a:ln w="0">
            <a:noFill/>
          </a:ln>
        </p:spPr>
        <p:txBody>
          <a:bodyPr lIns="63720" rIns="6372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38280"/>
                <a:tab algn="l" pos="1276200"/>
                <a:tab algn="l" pos="1914480"/>
                <a:tab algn="l" pos="2552760"/>
                <a:tab algn="l" pos="3191040"/>
                <a:tab algn="l" pos="3828960"/>
                <a:tab algn="l" pos="4467240"/>
                <a:tab algn="l" pos="5105520"/>
                <a:tab algn="l" pos="5743440"/>
                <a:tab algn="l" pos="6381720"/>
                <a:tab algn="l" pos="7020000"/>
                <a:tab algn="l" pos="7658280"/>
                <a:tab algn="l" pos="8296200"/>
                <a:tab algn="l" pos="8934480"/>
                <a:tab algn="l" pos="9572760"/>
                <a:tab algn="l" pos="10210680"/>
                <a:tab algn="l" pos="1084896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2852280" y="1301400"/>
            <a:ext cx="2450160" cy="1756800"/>
          </a:xfrm>
          <a:prstGeom prst="rect">
            <a:avLst/>
          </a:prstGeom>
          <a:noFill/>
          <a:ln w="0">
            <a:noFill/>
          </a:ln>
        </p:spPr>
        <p:txBody>
          <a:bodyPr lIns="63720" rIns="6372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38280"/>
                <a:tab algn="l" pos="1276200"/>
                <a:tab algn="l" pos="1914480"/>
                <a:tab algn="l" pos="2552760"/>
                <a:tab algn="l" pos="3191040"/>
                <a:tab algn="l" pos="3828960"/>
                <a:tab algn="l" pos="4467240"/>
                <a:tab algn="l" pos="5105520"/>
                <a:tab algn="l" pos="5743440"/>
                <a:tab algn="l" pos="6381720"/>
                <a:tab algn="l" pos="7020000"/>
                <a:tab algn="l" pos="7658280"/>
                <a:tab algn="l" pos="8296200"/>
                <a:tab algn="l" pos="8934480"/>
                <a:tab algn="l" pos="9572760"/>
                <a:tab algn="l" pos="10210680"/>
                <a:tab algn="l" pos="1084896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2852280" y="3225600"/>
            <a:ext cx="2450160" cy="1756800"/>
          </a:xfrm>
          <a:prstGeom prst="rect">
            <a:avLst/>
          </a:prstGeom>
          <a:noFill/>
          <a:ln w="0">
            <a:noFill/>
          </a:ln>
        </p:spPr>
        <p:txBody>
          <a:bodyPr lIns="63720" rIns="6372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38280"/>
                <a:tab algn="l" pos="1276200"/>
                <a:tab algn="l" pos="1914480"/>
                <a:tab algn="l" pos="2552760"/>
                <a:tab algn="l" pos="3191040"/>
                <a:tab algn="l" pos="3828960"/>
                <a:tab algn="l" pos="4467240"/>
                <a:tab algn="l" pos="5105520"/>
                <a:tab algn="l" pos="5743440"/>
                <a:tab algn="l" pos="6381720"/>
                <a:tab algn="l" pos="7020000"/>
                <a:tab algn="l" pos="7658280"/>
                <a:tab algn="l" pos="8296200"/>
                <a:tab algn="l" pos="8934480"/>
                <a:tab algn="l" pos="9572760"/>
                <a:tab algn="l" pos="10210680"/>
                <a:tab algn="l" pos="1084896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D6D2EB-6DB7-4B40-922F-EAD7479EDD0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279360" y="223920"/>
            <a:ext cx="5021280" cy="930240"/>
          </a:xfrm>
          <a:prstGeom prst="rect">
            <a:avLst/>
          </a:prstGeom>
          <a:noFill/>
          <a:ln w="0">
            <a:noFill/>
          </a:ln>
        </p:spPr>
        <p:txBody>
          <a:bodyPr lIns="63720" rIns="63720" tIns="32040" bIns="32040" anchor="ctr">
            <a:noAutofit/>
          </a:bodyPr>
          <a:p>
            <a:pPr indent="0" algn="ctr">
              <a:buNone/>
              <a:tabLst>
                <a:tab algn="l" pos="0"/>
                <a:tab algn="l" pos="638280"/>
                <a:tab algn="l" pos="1276200"/>
                <a:tab algn="l" pos="1914480"/>
                <a:tab algn="l" pos="2552760"/>
                <a:tab algn="l" pos="3191040"/>
                <a:tab algn="l" pos="3828960"/>
                <a:tab algn="l" pos="4467240"/>
                <a:tab algn="l" pos="5105520"/>
                <a:tab algn="l" pos="5743440"/>
                <a:tab algn="l" pos="6381720"/>
                <a:tab algn="l" pos="7020000"/>
                <a:tab algn="l" pos="7658280"/>
                <a:tab algn="l" pos="8296200"/>
                <a:tab algn="l" pos="8934480"/>
                <a:tab algn="l" pos="9572760"/>
                <a:tab algn="l" pos="10210680"/>
                <a:tab algn="l" pos="10848960"/>
              </a:tabLst>
            </a:pPr>
            <a:endParaRPr b="0" lang="en-US" sz="3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279360" y="1301400"/>
            <a:ext cx="2450160" cy="1756800"/>
          </a:xfrm>
          <a:prstGeom prst="rect">
            <a:avLst/>
          </a:prstGeom>
          <a:noFill/>
          <a:ln w="0">
            <a:noFill/>
          </a:ln>
        </p:spPr>
        <p:txBody>
          <a:bodyPr lIns="63720" rIns="6372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38280"/>
                <a:tab algn="l" pos="1276200"/>
                <a:tab algn="l" pos="1914480"/>
                <a:tab algn="l" pos="2552760"/>
                <a:tab algn="l" pos="3191040"/>
                <a:tab algn="l" pos="3828960"/>
                <a:tab algn="l" pos="4467240"/>
                <a:tab algn="l" pos="5105520"/>
                <a:tab algn="l" pos="5743440"/>
                <a:tab algn="l" pos="6381720"/>
                <a:tab algn="l" pos="7020000"/>
                <a:tab algn="l" pos="7658280"/>
                <a:tab algn="l" pos="8296200"/>
                <a:tab algn="l" pos="8934480"/>
                <a:tab algn="l" pos="9572760"/>
                <a:tab algn="l" pos="10210680"/>
                <a:tab algn="l" pos="1084896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2852280" y="1301400"/>
            <a:ext cx="2450160" cy="1756800"/>
          </a:xfrm>
          <a:prstGeom prst="rect">
            <a:avLst/>
          </a:prstGeom>
          <a:noFill/>
          <a:ln w="0">
            <a:noFill/>
          </a:ln>
        </p:spPr>
        <p:txBody>
          <a:bodyPr lIns="63720" rIns="6372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38280"/>
                <a:tab algn="l" pos="1276200"/>
                <a:tab algn="l" pos="1914480"/>
                <a:tab algn="l" pos="2552760"/>
                <a:tab algn="l" pos="3191040"/>
                <a:tab algn="l" pos="3828960"/>
                <a:tab algn="l" pos="4467240"/>
                <a:tab algn="l" pos="5105520"/>
                <a:tab algn="l" pos="5743440"/>
                <a:tab algn="l" pos="6381720"/>
                <a:tab algn="l" pos="7020000"/>
                <a:tab algn="l" pos="7658280"/>
                <a:tab algn="l" pos="8296200"/>
                <a:tab algn="l" pos="8934480"/>
                <a:tab algn="l" pos="9572760"/>
                <a:tab algn="l" pos="10210680"/>
                <a:tab algn="l" pos="1084896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279360" y="3225600"/>
            <a:ext cx="5021280" cy="1756800"/>
          </a:xfrm>
          <a:prstGeom prst="rect">
            <a:avLst/>
          </a:prstGeom>
          <a:noFill/>
          <a:ln w="0">
            <a:noFill/>
          </a:ln>
        </p:spPr>
        <p:txBody>
          <a:bodyPr lIns="63720" rIns="6372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38280"/>
                <a:tab algn="l" pos="1276200"/>
                <a:tab algn="l" pos="1914480"/>
                <a:tab algn="l" pos="2552760"/>
                <a:tab algn="l" pos="3191040"/>
                <a:tab algn="l" pos="3828960"/>
                <a:tab algn="l" pos="4467240"/>
                <a:tab algn="l" pos="5105520"/>
                <a:tab algn="l" pos="5743440"/>
                <a:tab algn="l" pos="6381720"/>
                <a:tab algn="l" pos="7020000"/>
                <a:tab algn="l" pos="7658280"/>
                <a:tab algn="l" pos="8296200"/>
                <a:tab algn="l" pos="8934480"/>
                <a:tab algn="l" pos="9572760"/>
                <a:tab algn="l" pos="10210680"/>
                <a:tab algn="l" pos="1084896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6591BC-2AE4-4D92-8BD2-A6DDDAE3867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279360" y="223920"/>
            <a:ext cx="5021280" cy="930240"/>
          </a:xfrm>
          <a:prstGeom prst="rect">
            <a:avLst/>
          </a:prstGeom>
          <a:noFill/>
          <a:ln w="0">
            <a:noFill/>
          </a:ln>
        </p:spPr>
        <p:txBody>
          <a:bodyPr lIns="63720" rIns="63720" tIns="32040" bIns="32040" anchor="ctr">
            <a:noAutofit/>
          </a:bodyPr>
          <a:p>
            <a:pPr indent="0" algn="ctr">
              <a:buNone/>
              <a:tabLst>
                <a:tab algn="l" pos="0"/>
                <a:tab algn="l" pos="638280"/>
                <a:tab algn="l" pos="1276200"/>
                <a:tab algn="l" pos="1914480"/>
                <a:tab algn="l" pos="2552760"/>
                <a:tab algn="l" pos="3191040"/>
                <a:tab algn="l" pos="3828960"/>
                <a:tab algn="l" pos="4467240"/>
                <a:tab algn="l" pos="5105520"/>
                <a:tab algn="l" pos="5743440"/>
                <a:tab algn="l" pos="6381720"/>
                <a:tab algn="l" pos="7020000"/>
                <a:tab algn="l" pos="7658280"/>
                <a:tab algn="l" pos="8296200"/>
                <a:tab algn="l" pos="8934480"/>
                <a:tab algn="l" pos="9572760"/>
                <a:tab algn="l" pos="10210680"/>
                <a:tab algn="l" pos="10848960"/>
              </a:tabLst>
            </a:pPr>
            <a:r>
              <a:rPr b="0" lang="en-US" sz="31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279360" y="1301400"/>
            <a:ext cx="5021280" cy="3683160"/>
          </a:xfrm>
          <a:prstGeom prst="rect">
            <a:avLst/>
          </a:prstGeom>
          <a:noFill/>
          <a:ln w="0">
            <a:noFill/>
          </a:ln>
        </p:spPr>
        <p:txBody>
          <a:bodyPr lIns="63720" rIns="63720" tIns="32040" bIns="32040" anchor="t">
            <a:normAutofit/>
          </a:bodyPr>
          <a:p>
            <a:pPr marL="239760" indent="-239760">
              <a:spcBef>
                <a:spcPts val="550"/>
              </a:spcBef>
              <a:buClr>
                <a:srgbClr val="000000"/>
              </a:buClr>
              <a:buFont typeface="Arial"/>
              <a:buChar char="•"/>
              <a:tabLst>
                <a:tab algn="l" pos="638280"/>
                <a:tab algn="l" pos="1276200"/>
                <a:tab algn="l" pos="1914480"/>
                <a:tab algn="l" pos="2552760"/>
                <a:tab algn="l" pos="3191040"/>
                <a:tab algn="l" pos="3828960"/>
                <a:tab algn="l" pos="4467240"/>
                <a:tab algn="l" pos="5105520"/>
                <a:tab algn="l" pos="5743440"/>
                <a:tab algn="l" pos="6381720"/>
                <a:tab algn="l" pos="7020000"/>
                <a:tab algn="l" pos="7658280"/>
                <a:tab algn="l" pos="8296200"/>
                <a:tab algn="l" pos="8934480"/>
                <a:tab algn="l" pos="9572760"/>
                <a:tab algn="l" pos="10210680"/>
                <a:tab algn="l" pos="1084896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  <a:p>
            <a:pPr lvl="1" marL="517680" indent="-198720">
              <a:spcBef>
                <a:spcPts val="550"/>
              </a:spcBef>
              <a:buClr>
                <a:srgbClr val="000000"/>
              </a:buClr>
              <a:buFont typeface="Arial"/>
              <a:buChar char="–"/>
              <a:tabLst>
                <a:tab algn="l" pos="638280"/>
                <a:tab algn="l" pos="1276200"/>
                <a:tab algn="l" pos="1914480"/>
                <a:tab algn="l" pos="2552760"/>
                <a:tab algn="l" pos="3191040"/>
                <a:tab algn="l" pos="3828960"/>
                <a:tab algn="l" pos="4467240"/>
                <a:tab algn="l" pos="5105520"/>
                <a:tab algn="l" pos="5743440"/>
                <a:tab algn="l" pos="6381720"/>
                <a:tab algn="l" pos="7020000"/>
                <a:tab algn="l" pos="7658280"/>
                <a:tab algn="l" pos="8296200"/>
                <a:tab algn="l" pos="8934480"/>
                <a:tab algn="l" pos="9572760"/>
                <a:tab algn="l" pos="10210680"/>
                <a:tab algn="l" pos="1084896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  <a:p>
            <a:pPr lvl="2" marL="797040" indent="-158760">
              <a:spcBef>
                <a:spcPts val="550"/>
              </a:spcBef>
              <a:buClr>
                <a:srgbClr val="000000"/>
              </a:buClr>
              <a:buFont typeface="Arial"/>
              <a:buChar char="•"/>
              <a:tabLst>
                <a:tab algn="l" pos="638280"/>
                <a:tab algn="l" pos="1276200"/>
                <a:tab algn="l" pos="1914480"/>
                <a:tab algn="l" pos="2552760"/>
                <a:tab algn="l" pos="3191040"/>
                <a:tab algn="l" pos="3828960"/>
                <a:tab algn="l" pos="4467240"/>
                <a:tab algn="l" pos="5105520"/>
                <a:tab algn="l" pos="5743440"/>
                <a:tab algn="l" pos="6381720"/>
                <a:tab algn="l" pos="7020000"/>
                <a:tab algn="l" pos="7658280"/>
                <a:tab algn="l" pos="8296200"/>
                <a:tab algn="l" pos="8934480"/>
                <a:tab algn="l" pos="9572760"/>
                <a:tab algn="l" pos="10210680"/>
                <a:tab algn="l" pos="1084896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  <a:p>
            <a:pPr lvl="3" marL="1116000" indent="-158760">
              <a:spcBef>
                <a:spcPts val="550"/>
              </a:spcBef>
              <a:buClr>
                <a:srgbClr val="000000"/>
              </a:buClr>
              <a:buFont typeface="Arial"/>
              <a:buChar char="–"/>
              <a:tabLst>
                <a:tab algn="l" pos="638280"/>
                <a:tab algn="l" pos="1276200"/>
                <a:tab algn="l" pos="1914480"/>
                <a:tab algn="l" pos="2552760"/>
                <a:tab algn="l" pos="3191040"/>
                <a:tab algn="l" pos="3828960"/>
                <a:tab algn="l" pos="4467240"/>
                <a:tab algn="l" pos="5105520"/>
                <a:tab algn="l" pos="5743440"/>
                <a:tab algn="l" pos="6381720"/>
                <a:tab algn="l" pos="7020000"/>
                <a:tab algn="l" pos="7658280"/>
                <a:tab algn="l" pos="8296200"/>
                <a:tab algn="l" pos="8934480"/>
                <a:tab algn="l" pos="9572760"/>
                <a:tab algn="l" pos="10210680"/>
                <a:tab algn="l" pos="1084896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  <a:p>
            <a:pPr lvl="4" marL="1434960" indent="-160200">
              <a:spcBef>
                <a:spcPts val="550"/>
              </a:spcBef>
              <a:buClr>
                <a:srgbClr val="000000"/>
              </a:buClr>
              <a:buFont typeface="Arial"/>
              <a:buChar char="»"/>
              <a:tabLst>
                <a:tab algn="l" pos="638280"/>
                <a:tab algn="l" pos="1276200"/>
                <a:tab algn="l" pos="1914480"/>
                <a:tab algn="l" pos="2552760"/>
                <a:tab algn="l" pos="3191040"/>
                <a:tab algn="l" pos="3828960"/>
                <a:tab algn="l" pos="4467240"/>
                <a:tab algn="l" pos="5105520"/>
                <a:tab algn="l" pos="5743440"/>
                <a:tab algn="l" pos="6381720"/>
                <a:tab algn="l" pos="7020000"/>
                <a:tab algn="l" pos="7658280"/>
                <a:tab algn="l" pos="8296200"/>
                <a:tab algn="l" pos="8934480"/>
                <a:tab algn="l" pos="9572760"/>
                <a:tab algn="l" pos="10210680"/>
                <a:tab algn="l" pos="1084896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  <a:p>
            <a:pPr lvl="5" marL="1434960" indent="-160200">
              <a:spcBef>
                <a:spcPts val="550"/>
              </a:spcBef>
              <a:buClr>
                <a:srgbClr val="000000"/>
              </a:buClr>
              <a:buFont typeface="Arial"/>
              <a:buChar char="»"/>
              <a:tabLst>
                <a:tab algn="l" pos="638280"/>
                <a:tab algn="l" pos="1276200"/>
                <a:tab algn="l" pos="1914480"/>
                <a:tab algn="l" pos="2552760"/>
                <a:tab algn="l" pos="3191040"/>
                <a:tab algn="l" pos="3828960"/>
                <a:tab algn="l" pos="4467240"/>
                <a:tab algn="l" pos="5105520"/>
                <a:tab algn="l" pos="5743440"/>
                <a:tab algn="l" pos="6381720"/>
                <a:tab algn="l" pos="7020000"/>
                <a:tab algn="l" pos="7658280"/>
                <a:tab algn="l" pos="8296200"/>
                <a:tab algn="l" pos="8934480"/>
                <a:tab algn="l" pos="9572760"/>
                <a:tab algn="l" pos="10210680"/>
                <a:tab algn="l" pos="1084896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  <a:p>
            <a:pPr lvl="6" marL="1434960" indent="-160200">
              <a:spcBef>
                <a:spcPts val="550"/>
              </a:spcBef>
              <a:buClr>
                <a:srgbClr val="000000"/>
              </a:buClr>
              <a:buFont typeface="Arial"/>
              <a:buChar char="»"/>
              <a:tabLst>
                <a:tab algn="l" pos="638280"/>
                <a:tab algn="l" pos="1276200"/>
                <a:tab algn="l" pos="1914480"/>
                <a:tab algn="l" pos="2552760"/>
                <a:tab algn="l" pos="3191040"/>
                <a:tab algn="l" pos="3828960"/>
                <a:tab algn="l" pos="4467240"/>
                <a:tab algn="l" pos="5105520"/>
                <a:tab algn="l" pos="5743440"/>
                <a:tab algn="l" pos="6381720"/>
                <a:tab algn="l" pos="7020000"/>
                <a:tab algn="l" pos="7658280"/>
                <a:tab algn="l" pos="8296200"/>
                <a:tab algn="l" pos="8934480"/>
                <a:tab algn="l" pos="9572760"/>
                <a:tab algn="l" pos="10210680"/>
                <a:tab algn="l" pos="1084896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279360" y="5081400"/>
            <a:ext cx="1301760" cy="387000"/>
          </a:xfrm>
          <a:prstGeom prst="rect">
            <a:avLst/>
          </a:prstGeom>
          <a:noFill/>
          <a:ln w="0">
            <a:noFill/>
          </a:ln>
        </p:spPr>
        <p:txBody>
          <a:bodyPr lIns="63720" rIns="63720" tIns="32040" bIns="32040" anchor="t">
            <a:noAutofit/>
          </a:bodyPr>
          <a:lstStyle>
            <a:lvl1pPr indent="0">
              <a:buNone/>
              <a:tabLst>
                <a:tab algn="l" pos="0"/>
                <a:tab algn="l" pos="638280"/>
                <a:tab algn="l" pos="1276200"/>
                <a:tab algn="l" pos="1914480"/>
                <a:tab algn="l" pos="2552760"/>
                <a:tab algn="l" pos="3191040"/>
                <a:tab algn="l" pos="3828960"/>
                <a:tab algn="l" pos="4467240"/>
                <a:tab algn="l" pos="5105520"/>
                <a:tab algn="l" pos="5743440"/>
                <a:tab algn="l" pos="6381720"/>
                <a:tab algn="l" pos="7020000"/>
                <a:tab algn="l" pos="7658280"/>
                <a:tab algn="l" pos="8296200"/>
                <a:tab algn="l" pos="8934480"/>
                <a:tab algn="l" pos="9572760"/>
                <a:tab algn="l" pos="10210680"/>
                <a:tab algn="l" pos="10848960"/>
              </a:tabLst>
              <a:defRPr b="0" lang="en-US" sz="10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638280"/>
                <a:tab algn="l" pos="1276200"/>
                <a:tab algn="l" pos="1914480"/>
                <a:tab algn="l" pos="2552760"/>
                <a:tab algn="l" pos="3191040"/>
                <a:tab algn="l" pos="3828960"/>
                <a:tab algn="l" pos="4467240"/>
                <a:tab algn="l" pos="5105520"/>
                <a:tab algn="l" pos="5743440"/>
                <a:tab algn="l" pos="6381720"/>
                <a:tab algn="l" pos="7020000"/>
                <a:tab algn="l" pos="7658280"/>
                <a:tab algn="l" pos="8296200"/>
                <a:tab algn="l" pos="8934480"/>
                <a:tab algn="l" pos="9572760"/>
                <a:tab algn="l" pos="10210680"/>
                <a:tab algn="l" pos="1084896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1906560" y="5081400"/>
            <a:ext cx="1766880" cy="387000"/>
          </a:xfrm>
          <a:prstGeom prst="rect">
            <a:avLst/>
          </a:prstGeom>
          <a:noFill/>
          <a:ln w="0">
            <a:noFill/>
          </a:ln>
        </p:spPr>
        <p:txBody>
          <a:bodyPr lIns="63720" rIns="63720" tIns="32040" bIns="32040" anchor="t">
            <a:noAutofit/>
          </a:bodyPr>
          <a:lstStyle>
            <a:lvl1pPr indent="0" algn="ctr">
              <a:buNone/>
              <a:tabLst>
                <a:tab algn="l" pos="0"/>
                <a:tab algn="l" pos="638280"/>
                <a:tab algn="l" pos="1276200"/>
                <a:tab algn="l" pos="1914480"/>
                <a:tab algn="l" pos="2552760"/>
                <a:tab algn="l" pos="3191040"/>
                <a:tab algn="l" pos="3828960"/>
                <a:tab algn="l" pos="4467240"/>
                <a:tab algn="l" pos="5105520"/>
                <a:tab algn="l" pos="5743440"/>
                <a:tab algn="l" pos="6381720"/>
                <a:tab algn="l" pos="7020000"/>
                <a:tab algn="l" pos="7658280"/>
                <a:tab algn="l" pos="8296200"/>
                <a:tab algn="l" pos="8934480"/>
                <a:tab algn="l" pos="9572760"/>
                <a:tab algn="l" pos="10210680"/>
                <a:tab algn="l" pos="10848960"/>
              </a:tabLst>
              <a:defRPr b="0" lang="en-US" sz="10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638280"/>
                <a:tab algn="l" pos="1276200"/>
                <a:tab algn="l" pos="1914480"/>
                <a:tab algn="l" pos="2552760"/>
                <a:tab algn="l" pos="3191040"/>
                <a:tab algn="l" pos="3828960"/>
                <a:tab algn="l" pos="4467240"/>
                <a:tab algn="l" pos="5105520"/>
                <a:tab algn="l" pos="5743440"/>
                <a:tab algn="l" pos="6381720"/>
                <a:tab algn="l" pos="7020000"/>
                <a:tab algn="l" pos="7658280"/>
                <a:tab algn="l" pos="8296200"/>
                <a:tab algn="l" pos="8934480"/>
                <a:tab algn="l" pos="9572760"/>
                <a:tab algn="l" pos="10210680"/>
                <a:tab algn="l" pos="1084896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3998880" y="5081400"/>
            <a:ext cx="1301760" cy="387000"/>
          </a:xfrm>
          <a:prstGeom prst="rect">
            <a:avLst/>
          </a:prstGeom>
          <a:noFill/>
          <a:ln w="0">
            <a:noFill/>
          </a:ln>
        </p:spPr>
        <p:txBody>
          <a:bodyPr lIns="63720" rIns="63720" tIns="32040" bIns="32040" anchor="t">
            <a:noAutofit/>
          </a:bodyPr>
          <a:lstStyle>
            <a:lvl1pPr indent="0" algn="r">
              <a:buNone/>
              <a:tabLst>
                <a:tab algn="l" pos="0"/>
                <a:tab algn="l" pos="638280"/>
                <a:tab algn="l" pos="1276200"/>
                <a:tab algn="l" pos="1914480"/>
                <a:tab algn="l" pos="2552760"/>
                <a:tab algn="l" pos="3191040"/>
                <a:tab algn="l" pos="3828960"/>
                <a:tab algn="l" pos="4467240"/>
                <a:tab algn="l" pos="5105520"/>
                <a:tab algn="l" pos="5743440"/>
                <a:tab algn="l" pos="6381720"/>
                <a:tab algn="l" pos="7020000"/>
                <a:tab algn="l" pos="7658280"/>
                <a:tab algn="l" pos="8296200"/>
                <a:tab algn="l" pos="8934480"/>
                <a:tab algn="l" pos="9572760"/>
                <a:tab algn="l" pos="10210680"/>
                <a:tab algn="l" pos="10848960"/>
              </a:tabLst>
              <a:defRPr b="0" lang="en-US" sz="10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638280"/>
                <a:tab algn="l" pos="1276200"/>
                <a:tab algn="l" pos="1914480"/>
                <a:tab algn="l" pos="2552760"/>
                <a:tab algn="l" pos="3191040"/>
                <a:tab algn="l" pos="3828960"/>
                <a:tab algn="l" pos="4467240"/>
                <a:tab algn="l" pos="5105520"/>
                <a:tab algn="l" pos="5743440"/>
                <a:tab algn="l" pos="6381720"/>
                <a:tab algn="l" pos="7020000"/>
                <a:tab algn="l" pos="7658280"/>
                <a:tab algn="l" pos="8296200"/>
                <a:tab algn="l" pos="8934480"/>
                <a:tab algn="l" pos="9572760"/>
                <a:tab algn="l" pos="10210680"/>
                <a:tab algn="l" pos="10848960"/>
              </a:tabLst>
            </a:pPr>
            <a:fld id="{2916067E-F7D6-4711-B3E1-F0A15BE1A067}" type="slidenum">
              <a:rPr b="0" lang="en-US" sz="10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wmf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rcRect l="7144" t="4967" r="30391" b="4630"/>
          <a:stretch/>
        </p:blipFill>
        <p:spPr>
          <a:xfrm>
            <a:off x="200160" y="90360"/>
            <a:ext cx="3886200" cy="5114880"/>
          </a:xfrm>
          <a:prstGeom prst="rect">
            <a:avLst/>
          </a:prstGeom>
          <a:ln w="0">
            <a:noFill/>
          </a:ln>
        </p:spPr>
      </p:pic>
      <p:grpSp>
        <p:nvGrpSpPr>
          <p:cNvPr id="42" name=""/>
          <p:cNvGrpSpPr/>
          <p:nvPr/>
        </p:nvGrpSpPr>
        <p:grpSpPr>
          <a:xfrm>
            <a:off x="4016520" y="47520"/>
            <a:ext cx="1104840" cy="5190480"/>
            <a:chOff x="4016520" y="47520"/>
            <a:chExt cx="1104840" cy="5190480"/>
          </a:xfrm>
        </p:grpSpPr>
        <p:sp>
          <p:nvSpPr>
            <p:cNvPr id="43" name=""/>
            <p:cNvSpPr/>
            <p:nvPr/>
          </p:nvSpPr>
          <p:spPr>
            <a:xfrm>
              <a:off x="4016520" y="47520"/>
              <a:ext cx="11048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CD27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4016520" y="4613400"/>
              <a:ext cx="11048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CD18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4016520" y="162000"/>
              <a:ext cx="11048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CD196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4016520" y="289080"/>
              <a:ext cx="11048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IGL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4016520" y="422280"/>
              <a:ext cx="11048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CD79A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4016520" y="555480"/>
              <a:ext cx="11048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CD79B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4016520" y="695520"/>
              <a:ext cx="11048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CD2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4016520" y="835200"/>
              <a:ext cx="11048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CD19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4016520" y="961920"/>
              <a:ext cx="11048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CD2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4016520" y="1076400"/>
              <a:ext cx="11048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IGH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4016520" y="1203480"/>
              <a:ext cx="11048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CD2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4016520" y="1349280"/>
              <a:ext cx="11048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CD32B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4016520" y="1488960"/>
              <a:ext cx="11048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CD1C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4016520" y="1603440"/>
              <a:ext cx="11048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CD74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4016520" y="1736640"/>
              <a:ext cx="11048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CD3D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4016520" y="1863720"/>
              <a:ext cx="11048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CD3G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4016520" y="1990800"/>
              <a:ext cx="11048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CD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4016520" y="2124000"/>
              <a:ext cx="11048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CD28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4016520" y="2257560"/>
              <a:ext cx="11048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CD3Z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4016520" y="2403360"/>
              <a:ext cx="11048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CD3E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4016520" y="2517840"/>
              <a:ext cx="11048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TCRA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4016520" y="2657520"/>
              <a:ext cx="11048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TCRB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4016520" y="2778120"/>
              <a:ext cx="11048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CD197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4016520" y="2911680"/>
              <a:ext cx="11048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CD8B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4016520" y="3051360"/>
              <a:ext cx="11048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CD8A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4016520" y="3178080"/>
              <a:ext cx="11048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CD94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4016520" y="3298680"/>
              <a:ext cx="11048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CD19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4016520" y="3432240"/>
              <a:ext cx="11048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CD36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4016520" y="3565440"/>
              <a:ext cx="11048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CD14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4016520" y="3705120"/>
              <a:ext cx="11048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CD89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4016520" y="3832200"/>
              <a:ext cx="11048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CD284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4016520" y="3952800"/>
              <a:ext cx="11048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CD28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4016520" y="4086360"/>
              <a:ext cx="11048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CD1D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4016520" y="4219560"/>
              <a:ext cx="11048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CD86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4016520" y="4353120"/>
              <a:ext cx="11048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CD4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4016520" y="4486320"/>
              <a:ext cx="11048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CD19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4016520" y="4740480"/>
              <a:ext cx="11048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CD18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4016520" y="4880160"/>
              <a:ext cx="11048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CD16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4016520" y="5006880"/>
              <a:ext cx="11048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CD32A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2" name=""/>
          <p:cNvGrpSpPr/>
          <p:nvPr/>
        </p:nvGrpSpPr>
        <p:grpSpPr>
          <a:xfrm>
            <a:off x="158760" y="5200560"/>
            <a:ext cx="4014720" cy="292320"/>
            <a:chOff x="158760" y="5200560"/>
            <a:chExt cx="4014720" cy="292320"/>
          </a:xfrm>
        </p:grpSpPr>
        <p:grpSp>
          <p:nvGrpSpPr>
            <p:cNvPr id="83" name=""/>
            <p:cNvGrpSpPr/>
            <p:nvPr/>
          </p:nvGrpSpPr>
          <p:grpSpPr>
            <a:xfrm>
              <a:off x="247680" y="5200560"/>
              <a:ext cx="3816000" cy="76320"/>
              <a:chOff x="247680" y="5200560"/>
              <a:chExt cx="3816000" cy="76320"/>
            </a:xfrm>
          </p:grpSpPr>
          <p:sp>
            <p:nvSpPr>
              <p:cNvPr id="84" name=""/>
              <p:cNvSpPr/>
              <p:nvPr/>
            </p:nvSpPr>
            <p:spPr>
              <a:xfrm rot="16200000">
                <a:off x="585720" y="4862160"/>
                <a:ext cx="76320" cy="752760"/>
              </a:xfrm>
              <a:custGeom>
                <a:avLst/>
                <a:gdLst>
                  <a:gd name="textAreaLeft" fmla="*/ 22320 w 76320"/>
                  <a:gd name="textAreaRight" fmla="*/ 76320 w 76320"/>
                  <a:gd name="textAreaTop" fmla="*/ 31320 h 752760"/>
                  <a:gd name="textAreaBottom" fmla="*/ 721440 h 75276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21600" y="0"/>
                    </a:moveTo>
                    <a:cubicBezTo>
                      <a:pt x="10800" y="0"/>
                      <a:pt x="0" y="900"/>
                      <a:pt x="0" y="1800"/>
                    </a:cubicBezTo>
                    <a:lnTo>
                      <a:pt x="0" y="19800"/>
                    </a:lnTo>
                    <a:cubicBezTo>
                      <a:pt x="0" y="20700"/>
                      <a:pt x="10800" y="21600"/>
                      <a:pt x="21600" y="21600"/>
                    </a:cubicBezTo>
                  </a:path>
                </a:pathLst>
              </a:cu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" name=""/>
              <p:cNvSpPr/>
              <p:nvPr/>
            </p:nvSpPr>
            <p:spPr>
              <a:xfrm rot="16200000">
                <a:off x="1351440" y="4862160"/>
                <a:ext cx="76320" cy="753120"/>
              </a:xfrm>
              <a:custGeom>
                <a:avLst/>
                <a:gdLst>
                  <a:gd name="textAreaLeft" fmla="*/ 22320 w 76320"/>
                  <a:gd name="textAreaRight" fmla="*/ 76320 w 76320"/>
                  <a:gd name="textAreaTop" fmla="*/ 31320 h 753120"/>
                  <a:gd name="textAreaBottom" fmla="*/ 721800 h 75312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21600" y="0"/>
                    </a:moveTo>
                    <a:cubicBezTo>
                      <a:pt x="10800" y="0"/>
                      <a:pt x="0" y="900"/>
                      <a:pt x="0" y="1800"/>
                    </a:cubicBezTo>
                    <a:lnTo>
                      <a:pt x="0" y="19800"/>
                    </a:lnTo>
                    <a:cubicBezTo>
                      <a:pt x="0" y="20700"/>
                      <a:pt x="10800" y="21600"/>
                      <a:pt x="21600" y="21600"/>
                    </a:cubicBezTo>
                  </a:path>
                </a:pathLst>
              </a:cu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" name=""/>
              <p:cNvSpPr/>
              <p:nvPr/>
            </p:nvSpPr>
            <p:spPr>
              <a:xfrm rot="16200000">
                <a:off x="2117160" y="4862160"/>
                <a:ext cx="76320" cy="752760"/>
              </a:xfrm>
              <a:custGeom>
                <a:avLst/>
                <a:gdLst>
                  <a:gd name="textAreaLeft" fmla="*/ 22320 w 76320"/>
                  <a:gd name="textAreaRight" fmla="*/ 76320 w 76320"/>
                  <a:gd name="textAreaTop" fmla="*/ 31320 h 752760"/>
                  <a:gd name="textAreaBottom" fmla="*/ 721440 h 75276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21600" y="0"/>
                    </a:moveTo>
                    <a:cubicBezTo>
                      <a:pt x="10800" y="0"/>
                      <a:pt x="0" y="900"/>
                      <a:pt x="0" y="1800"/>
                    </a:cubicBezTo>
                    <a:lnTo>
                      <a:pt x="0" y="19800"/>
                    </a:lnTo>
                    <a:cubicBezTo>
                      <a:pt x="0" y="20700"/>
                      <a:pt x="10800" y="21600"/>
                      <a:pt x="21600" y="21600"/>
                    </a:cubicBezTo>
                  </a:path>
                </a:pathLst>
              </a:cu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" name=""/>
              <p:cNvSpPr/>
              <p:nvPr/>
            </p:nvSpPr>
            <p:spPr>
              <a:xfrm rot="16200000">
                <a:off x="2882880" y="4862160"/>
                <a:ext cx="76320" cy="752760"/>
              </a:xfrm>
              <a:custGeom>
                <a:avLst/>
                <a:gdLst>
                  <a:gd name="textAreaLeft" fmla="*/ 22320 w 76320"/>
                  <a:gd name="textAreaRight" fmla="*/ 76320 w 76320"/>
                  <a:gd name="textAreaTop" fmla="*/ 31320 h 752760"/>
                  <a:gd name="textAreaBottom" fmla="*/ 721440 h 75276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21600" y="0"/>
                    </a:moveTo>
                    <a:cubicBezTo>
                      <a:pt x="10800" y="0"/>
                      <a:pt x="0" y="900"/>
                      <a:pt x="0" y="1800"/>
                    </a:cubicBezTo>
                    <a:lnTo>
                      <a:pt x="0" y="19800"/>
                    </a:lnTo>
                    <a:cubicBezTo>
                      <a:pt x="0" y="20700"/>
                      <a:pt x="10800" y="21600"/>
                      <a:pt x="21600" y="21600"/>
                    </a:cubicBezTo>
                  </a:path>
                </a:pathLst>
              </a:cu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" name=""/>
              <p:cNvSpPr/>
              <p:nvPr/>
            </p:nvSpPr>
            <p:spPr>
              <a:xfrm rot="16200000">
                <a:off x="3648960" y="4862160"/>
                <a:ext cx="76320" cy="753120"/>
              </a:xfrm>
              <a:custGeom>
                <a:avLst/>
                <a:gdLst>
                  <a:gd name="textAreaLeft" fmla="*/ 22320 w 76320"/>
                  <a:gd name="textAreaRight" fmla="*/ 76320 w 76320"/>
                  <a:gd name="textAreaTop" fmla="*/ 31320 h 753120"/>
                  <a:gd name="textAreaBottom" fmla="*/ 721800 h 75312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21600" y="0"/>
                    </a:moveTo>
                    <a:cubicBezTo>
                      <a:pt x="10800" y="0"/>
                      <a:pt x="0" y="900"/>
                      <a:pt x="0" y="1800"/>
                    </a:cubicBezTo>
                    <a:lnTo>
                      <a:pt x="0" y="19800"/>
                    </a:lnTo>
                    <a:cubicBezTo>
                      <a:pt x="0" y="20700"/>
                      <a:pt x="10800" y="21600"/>
                      <a:pt x="21600" y="21600"/>
                    </a:cubicBezTo>
                  </a:path>
                </a:pathLst>
              </a:cu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89" name=""/>
            <p:cNvSpPr/>
            <p:nvPr/>
          </p:nvSpPr>
          <p:spPr>
            <a:xfrm>
              <a:off x="158760" y="5246640"/>
              <a:ext cx="9144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</a:rPr>
                <a:t>Neutrophil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"/>
            <p:cNvSpPr/>
            <p:nvPr/>
          </p:nvSpPr>
          <p:spPr>
            <a:xfrm>
              <a:off x="925560" y="5246640"/>
              <a:ext cx="904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</a:rPr>
                <a:t>Monocyte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"/>
            <p:cNvSpPr/>
            <p:nvPr/>
          </p:nvSpPr>
          <p:spPr>
            <a:xfrm>
              <a:off x="1834920" y="5246640"/>
              <a:ext cx="666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B cell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"/>
            <p:cNvSpPr/>
            <p:nvPr/>
          </p:nvSpPr>
          <p:spPr>
            <a:xfrm>
              <a:off x="2473200" y="5246640"/>
              <a:ext cx="8762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CD4 T cell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"/>
            <p:cNvSpPr/>
            <p:nvPr/>
          </p:nvSpPr>
          <p:spPr>
            <a:xfrm>
              <a:off x="3192480" y="5246640"/>
              <a:ext cx="981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CD8 T cell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94" name="" descr=""/>
          <p:cNvPicPr/>
          <p:nvPr/>
        </p:nvPicPr>
        <p:blipFill>
          <a:blip r:embed="rId2"/>
          <a:stretch/>
        </p:blipFill>
        <p:spPr>
          <a:xfrm>
            <a:off x="4959360" y="550800"/>
            <a:ext cx="511200" cy="4211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1-12T12:40:04Z</dcterms:created>
  <dc:creator>plyons</dc:creator>
  <dc:description/>
  <dc:language>en-US</dc:language>
  <cp:lastModifiedBy>Paul Lyons</cp:lastModifiedBy>
  <dcterms:modified xsi:type="dcterms:W3CDTF">2007-03-01T16:41:04Z</dcterms:modified>
  <cp:revision>7</cp:revision>
  <dc:subject/>
  <dc:title>Slide 1</dc:title>
</cp:coreProperties>
</file>